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5" r:id="rId2"/>
    <p:sldId id="284" r:id="rId3"/>
    <p:sldId id="279" r:id="rId4"/>
    <p:sldId id="274" r:id="rId5"/>
    <p:sldId id="281" r:id="rId6"/>
    <p:sldId id="275" r:id="rId7"/>
    <p:sldId id="276" r:id="rId8"/>
    <p:sldId id="283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2132" y="-21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0413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5451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0757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608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9589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4555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4641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3514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8185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1751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4932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EA374-5F1C-48DE-85D8-E2E5DE4FDFB8}" type="datetimeFigureOut">
              <a:rPr lang="it-IT" smtClean="0"/>
              <a:t>17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5D3C3C-7C00-47A8-A0CE-65AE4965E9A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7787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51D8F33E-67FF-4A53-8D75-EEA5DC1D3EE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1777" y="3015932"/>
            <a:ext cx="4434445" cy="2196148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F7D3FFE3-352A-4E7D-BD28-B48FC56E996B}"/>
              </a:ext>
            </a:extLst>
          </p:cNvPr>
          <p:cNvSpPr txBox="1"/>
          <p:nvPr/>
        </p:nvSpPr>
        <p:spPr>
          <a:xfrm>
            <a:off x="1134941" y="5546787"/>
            <a:ext cx="4646428" cy="11449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 based-assay with transfected HEK cells expressing human IgLON5 showed reactivity (red) when cells were incubated with IgG purified from a patient with anti-IgLON5 disease (Pt-IgG, A), and negative results with incubation with IgG purified from a control subject (Ctrl-IgG). Nuclei were stained with DAPI (blue; D). The Pt-IgG reproduced the typical pattern of staining by immunohistochemistry of paraformaldehyde-fixed rat brain slices in the cerebellum (B) and hippocampus (C). Ctrl-IgG did not react with rat brain tissue in the cerebellum (E) or hippo-campus (F). Scale bars: 10 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D), 100 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E), 500 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F). </a:t>
            </a:r>
            <a:endParaRPr lang="it-IT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4326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8A4349C1-0667-4502-8B69-64323C1135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7780" y="3370951"/>
            <a:ext cx="4322439" cy="3164098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7701637E-9C69-4133-A86D-F35A631FA29A}"/>
              </a:ext>
            </a:extLst>
          </p:cNvPr>
          <p:cNvSpPr txBox="1"/>
          <p:nvPr/>
        </p:nvSpPr>
        <p:spPr>
          <a:xfrm>
            <a:off x="1256861" y="6735507"/>
            <a:ext cx="4646428" cy="881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ily profiles of neck muscle electromyogram root mean square (EMG, in arbitrary units, AU) in female wild-type (blue) and 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au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red) mice with intracerebroventricular infusion of antibodies from a patient with anti-IgLON5 disease (IgLON5) or from a control (CTRL) subject. Zeitgeber Time (ZT) is the time from lights on. Panels A and B show results obtained at the end of the 14-day infusion (d14) and ≥ 1 month afterward (d45). Bars show means ± SEM. Dots show values in individual mice. </a:t>
            </a:r>
            <a:endParaRPr lang="it-IT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97013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C7266F04-8A20-4E75-A4B3-1C5E5B48E9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7780" y="3383144"/>
            <a:ext cx="4322439" cy="3139712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CD20A3A5-730C-4609-BC9B-E350162A9299}"/>
              </a:ext>
            </a:extLst>
          </p:cNvPr>
          <p:cNvSpPr txBox="1"/>
          <p:nvPr/>
        </p:nvSpPr>
        <p:spPr>
          <a:xfrm>
            <a:off x="1105785" y="6735507"/>
            <a:ext cx="4646428" cy="881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ily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files of neck muscle electromyogram root mean square (EMG, in arbitrary units, AU) in male 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 with intracerebroventricular infusion of antibodies purified from a patient with anti-IgLON5 disease (IgLON5) or from a control (CTRL) subject. Zeitgeber Time (ZT) is the time from lights on. Panels A and B show results obtained at the end of the 14-day infusion (d14) and ≥ 1 month afterward (d45). Bars show means ± SEM. Dots show values in individual mice. </a:t>
            </a:r>
            <a:endParaRPr lang="it-IT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57226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A5C1754D-0145-4EBA-8DB3-BF3AD2BBB7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0428" y="2659380"/>
            <a:ext cx="3057144" cy="4587240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D6DF0C9E-B3B2-4ABD-888D-66E275EA35AC}"/>
              </a:ext>
            </a:extLst>
          </p:cNvPr>
          <p:cNvSpPr txBox="1"/>
          <p:nvPr/>
        </p:nvSpPr>
        <p:spPr>
          <a:xfrm>
            <a:off x="842631" y="7475736"/>
            <a:ext cx="5388049" cy="881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1200"/>
              </a:spcBef>
              <a:spcAft>
                <a:spcPts val="300"/>
              </a:spcAft>
            </a:pPr>
            <a:r>
              <a:rPr lang="en-US" sz="900" b="1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sz="900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ercentage of recording time spent in wakefulness (W), NREM sleep (N), and REM sleep (R) during the first 8 hours of the light period by male 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</a:t>
            </a:r>
            <a:r>
              <a:rPr lang="en-US" sz="900" i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</a:t>
            </a:r>
            <a:r>
              <a:rPr lang="en-US" sz="900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 with chronic intracerebroventricular infusion of antibodies purified from a patient with anti-IgLON5 disease (IgLON5) or from a control (CTRL) subject. Panels A, C, and E show results obtained at the end of the 14-day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usion</a:t>
            </a:r>
            <a:r>
              <a:rPr lang="en-US" sz="900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d14), while panels B, D, and F show results obtained ≥ 1 month afterward (d45). Bars show means ± SEM. Dots show values in individual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en-US" sz="900" i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Detailed statistical results are reported in Tables A2-A4. </a:t>
            </a:r>
            <a:endParaRPr lang="it-IT" sz="1000" i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9467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8894F8AA-73A1-4FE8-AE15-7F14176D73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0219" y="3444109"/>
            <a:ext cx="2877561" cy="3017782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7E4E76A0-CA15-40AF-8730-5D622FC02DDC}"/>
              </a:ext>
            </a:extLst>
          </p:cNvPr>
          <p:cNvSpPr txBox="1"/>
          <p:nvPr/>
        </p:nvSpPr>
        <p:spPr>
          <a:xfrm>
            <a:off x="1225402" y="6748065"/>
            <a:ext cx="4643769" cy="881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raw tracings of ventilation (pressure difference, ΔP, between whole-body plethysmograph, WBP, chambers; inspiration upwards), electroencephalographic (EEG) and electromyographic (EMG) signals during NREM sleep (A) and REM sleep (B) recorded in a female 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use upon termination of the 14-day period of intracerebroventricular infusion with antibodies from a patient with anti-IgLON5 disease. </a:t>
            </a:r>
            <a:endParaRPr lang="it-IT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47256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D5C7D279-F04C-46B9-B496-9802826825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0428" y="1095047"/>
            <a:ext cx="3057144" cy="5398008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EFE0A20F-6867-4136-B9EF-057ECBD410FA}"/>
              </a:ext>
            </a:extLst>
          </p:cNvPr>
          <p:cNvSpPr txBox="1"/>
          <p:nvPr/>
        </p:nvSpPr>
        <p:spPr>
          <a:xfrm>
            <a:off x="675097" y="6493055"/>
            <a:ext cx="5683174" cy="14080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dexes of sleep architecture (A-B) and quality (C-F) in male 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 with chronic intracerebroventricular infusion of antibodies from a patient with anti-IgLON5 disease (IgLON5) or from a control (CTRL) subject. Panels A and B show the square-root transformed numbers of episodes of NREM sleep with duration 4-8 s (b1), 12-120 s (b2) or &gt; 120 s (b3) per hour recording time during the first 8 hours of the light period. Panels C and D show log-transformed ratios of electromyogram (EMG) root mean square during sleep (N: NREM sleep; R: REM sleep) and during wakefulness (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MGw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Panels E and F show ratios of electroencephalogram (EEG) theta and delta power during N and R. Panels A, C, and E show data obtained at the end of the 14-day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usion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d14), while panels B, D, and F show results obtained ≥ 1 month afterward (d45). Bars show means ± SEM. Dots show values in individual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Detailed statistical results are reported in Tables A5-A7. </a:t>
            </a:r>
            <a:endParaRPr lang="it-IT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39363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F4C9339D-5493-4261-A5D7-089C687FB0A1}"/>
              </a:ext>
            </a:extLst>
          </p:cNvPr>
          <p:cNvSpPr txBox="1"/>
          <p:nvPr/>
        </p:nvSpPr>
        <p:spPr>
          <a:xfrm>
            <a:off x="1714500" y="6026041"/>
            <a:ext cx="3429000" cy="1539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s A and B show the square-root transformed number of apneas per hour of NREM (N) or REM (R) sleep time. Panels C and D show the ventilatory period (VP) during N and R. Data were obtained in male 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 with chronic intracerebroventricular infusion of antibodies from a patient with anti-IgLON5 disease (IgLON5) or from a control (CTRL) subject. Panels A and C show data obtained at the end of the 14-day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usion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d14), while panels B and D show results obtained ≥ 1 month afterward (d45). Bars show means ± SEM. Dots show values in individual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Detailed statistical results are reported in Tables A8-A9. </a:t>
            </a:r>
            <a:endParaRPr lang="it-IT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A5C6B71F-2227-458F-84E3-445BA419736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611" b="16239"/>
          <a:stretch/>
        </p:blipFill>
        <p:spPr>
          <a:xfrm>
            <a:off x="1900428" y="2941983"/>
            <a:ext cx="3057144" cy="30209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96958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C925A1DA-4457-49F5-BAE7-068C0E1DD9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0428" y="4189476"/>
            <a:ext cx="3057144" cy="1527048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03DA9B6D-B227-4C4F-AF1C-9D39821533A3}"/>
              </a:ext>
            </a:extLst>
          </p:cNvPr>
          <p:cNvSpPr txBox="1"/>
          <p:nvPr/>
        </p:nvSpPr>
        <p:spPr>
          <a:xfrm>
            <a:off x="1823787" y="5799740"/>
            <a:ext cx="3429000" cy="10133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 of the inter-lick intervals (ILI) in male 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 with chronic intracerebroventricular infusion of antibodies from a patient with anti-IgLON5 disease (IgLON5) or from a control (CTRL) subject, measured at the end of the 14-day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usion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d14, A) and ≥ 1 month afterward (d45, B). Bars show means ± SEM. Dots show values in individual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Detailed statistical results are reported in Table A11. </a:t>
            </a:r>
            <a:endParaRPr lang="it-IT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30254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18</TotalTime>
  <Words>939</Words>
  <Application>Microsoft Office PowerPoint</Application>
  <PresentationFormat>A4 Paper (210x297 mm)</PresentationFormat>
  <Paragraphs>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Palatino Linotype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andro Silvani</dc:creator>
  <cp:lastModifiedBy>MDPI-50</cp:lastModifiedBy>
  <cp:revision>104</cp:revision>
  <dcterms:created xsi:type="dcterms:W3CDTF">2020-08-15T16:10:00Z</dcterms:created>
  <dcterms:modified xsi:type="dcterms:W3CDTF">2022-03-17T15:10:16Z</dcterms:modified>
</cp:coreProperties>
</file>